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  <p:sldId id="258" r:id="rId8"/>
  </p:sldIdLst>
  <p:sldSz cy="9906000" cx="6858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GoogleSlidesCustomDataVersion2">
      <go:slidesCustomData xmlns:go="http://customooxmlschemas.google.com/" r:id="rId9" roundtripDataSignature="AMtx7mhpvD4owT4QKRP91t4uzldbFdM34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3120" orient="horz"/>
        <p:guide pos="216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customschemas.google.com/relationships/presentationmetadata" Target="metadata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61" name="Shape 1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Google Shape;162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63" name="Google Shape;163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5" name="Shape 2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Google Shape;246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47" name="Google Shape;247;p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5"/>
          <p:cNvSpPr txBox="1"/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5"/>
          <p:cNvSpPr txBox="1"/>
          <p:nvPr>
            <p:ph idx="1" type="subTitle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/>
        </p:txBody>
      </p:sp>
      <p:sp>
        <p:nvSpPr>
          <p:cNvPr id="14" name="Google Shape;14;p5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" name="Google Shape;15;p5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6" name="Google Shape;16;p5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4"/>
          <p:cNvSpPr txBox="1"/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4"/>
          <p:cNvSpPr txBox="1"/>
          <p:nvPr>
            <p:ph idx="1" type="body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4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4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4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5"/>
          <p:cNvSpPr txBox="1"/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5"/>
          <p:cNvSpPr txBox="1"/>
          <p:nvPr>
            <p:ph idx="1" type="body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5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5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5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17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6"/>
          <p:cNvSpPr txBox="1"/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6"/>
          <p:cNvSpPr txBox="1"/>
          <p:nvPr>
            <p:ph idx="1" type="body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0" name="Google Shape;20;p6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6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" name="Google Shape;22;p6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3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7"/>
          <p:cNvSpPr txBox="1"/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7"/>
          <p:cNvSpPr txBox="1"/>
          <p:nvPr>
            <p:ph idx="1" type="body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26" name="Google Shape;26;p7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7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8" name="Google Shape;28;p7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29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8"/>
          <p:cNvSpPr txBox="1"/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8"/>
          <p:cNvSpPr txBox="1"/>
          <p:nvPr>
            <p:ph idx="1" type="body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2" name="Google Shape;32;p8"/>
          <p:cNvSpPr txBox="1"/>
          <p:nvPr>
            <p:ph idx="2" type="body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3" name="Google Shape;33;p8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8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8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36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9"/>
          <p:cNvSpPr txBox="1"/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9"/>
          <p:cNvSpPr txBox="1"/>
          <p:nvPr>
            <p:ph idx="1" type="body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b="1" sz="150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b="1" sz="135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3" type="body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b="1" sz="150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b="1" sz="135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b="1" sz="1200"/>
            </a:lvl9pPr>
          </a:lstStyle>
          <a:p/>
        </p:txBody>
      </p:sp>
      <p:sp>
        <p:nvSpPr>
          <p:cNvPr id="41" name="Google Shape;41;p9"/>
          <p:cNvSpPr txBox="1"/>
          <p:nvPr>
            <p:ph idx="4" type="body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2" name="Google Shape;42;p9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9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4" name="Google Shape;44;p9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5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0"/>
          <p:cNvSpPr txBox="1"/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10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10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10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1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1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1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2"/>
          <p:cNvSpPr txBox="1"/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2"/>
          <p:cNvSpPr txBox="1"/>
          <p:nvPr>
            <p:ph idx="1" type="body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indent="-36195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indent="-3429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indent="-32385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indent="-32385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indent="-32385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indent="-32385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indent="-32385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indent="-32385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/>
        </p:txBody>
      </p:sp>
      <p:sp>
        <p:nvSpPr>
          <p:cNvPr id="57" name="Google Shape;57;p12"/>
          <p:cNvSpPr txBox="1"/>
          <p:nvPr>
            <p:ph idx="2" type="body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/>
        </p:txBody>
      </p:sp>
      <p:sp>
        <p:nvSpPr>
          <p:cNvPr id="58" name="Google Shape;58;p12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2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2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3"/>
          <p:cNvSpPr txBox="1"/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3"/>
          <p:cNvSpPr/>
          <p:nvPr>
            <p:ph idx="2" type="pic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3"/>
          <p:cNvSpPr txBox="1"/>
          <p:nvPr>
            <p:ph idx="1" type="body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indent="-228600" lvl="1" marL="914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indent="-228600" lvl="2" marL="1371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indent="-228600" lvl="3" marL="1828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indent="-228600" lvl="4" marL="2286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indent="-228600" lvl="5" marL="27432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indent="-228600" lvl="6" marL="3200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indent="-228600" lvl="7" marL="3657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indent="-228600" lvl="8" marL="411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/>
        </p:txBody>
      </p:sp>
      <p:sp>
        <p:nvSpPr>
          <p:cNvPr id="65" name="Google Shape;65;p13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3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3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4"/>
          <p:cNvSpPr txBox="1"/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b="0" i="0" sz="33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4"/>
          <p:cNvSpPr txBox="1"/>
          <p:nvPr>
            <p:ph idx="1" type="body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61950" lvl="0" marL="457200" marR="0" rtl="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b="0" i="0" sz="2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42900" lvl="1" marL="9144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23850" lvl="2" marL="13716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b="0" i="0" sz="15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14325" lvl="3" marL="18288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14325" lvl="4" marL="22860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14325" lvl="5" marL="27432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14325" lvl="6" marL="32004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14325" lvl="7" marL="36576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14325" lvl="8" marL="4114800" marR="0" rtl="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b="0" i="0" sz="135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4"/>
          <p:cNvSpPr txBox="1"/>
          <p:nvPr>
            <p:ph idx="10" type="dt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4"/>
          <p:cNvSpPr txBox="1"/>
          <p:nvPr>
            <p:ph idx="11" type="ftr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4"/>
          <p:cNvSpPr txBox="1"/>
          <p:nvPr>
            <p:ph idx="12" type="sldNum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9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1" Type="http://schemas.openxmlformats.org/officeDocument/2006/relationships/image" Target="../media/image2.png"/><Relationship Id="rId10" Type="http://schemas.openxmlformats.org/officeDocument/2006/relationships/image" Target="../media/image12.png"/><Relationship Id="rId13" Type="http://schemas.openxmlformats.org/officeDocument/2006/relationships/image" Target="../media/image18.png"/><Relationship Id="rId1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.png"/><Relationship Id="rId4" Type="http://schemas.openxmlformats.org/officeDocument/2006/relationships/image" Target="../media/image13.png"/><Relationship Id="rId9" Type="http://schemas.openxmlformats.org/officeDocument/2006/relationships/image" Target="../media/image16.png"/><Relationship Id="rId15" Type="http://schemas.openxmlformats.org/officeDocument/2006/relationships/image" Target="../media/image23.png"/><Relationship Id="rId14" Type="http://schemas.openxmlformats.org/officeDocument/2006/relationships/image" Target="../media/image40.png"/><Relationship Id="rId17" Type="http://schemas.openxmlformats.org/officeDocument/2006/relationships/image" Target="../media/image8.png"/><Relationship Id="rId16" Type="http://schemas.openxmlformats.org/officeDocument/2006/relationships/image" Target="../media/image10.png"/><Relationship Id="rId5" Type="http://schemas.openxmlformats.org/officeDocument/2006/relationships/image" Target="../media/image1.png"/><Relationship Id="rId6" Type="http://schemas.openxmlformats.org/officeDocument/2006/relationships/image" Target="../media/image7.png"/><Relationship Id="rId18" Type="http://schemas.openxmlformats.org/officeDocument/2006/relationships/image" Target="../media/image11.png"/><Relationship Id="rId7" Type="http://schemas.openxmlformats.org/officeDocument/2006/relationships/image" Target="../media/image27.png"/><Relationship Id="rId8" Type="http://schemas.openxmlformats.org/officeDocument/2006/relationships/image" Target="../media/image9.png"/></Relationships>
</file>

<file path=ppt/slides/_rels/slide2.xml.rels><?xml version="1.0" encoding="UTF-8" standalone="yes"?><Relationships xmlns="http://schemas.openxmlformats.org/package/2006/relationships"><Relationship Id="rId11" Type="http://schemas.openxmlformats.org/officeDocument/2006/relationships/image" Target="../media/image24.png"/><Relationship Id="rId10" Type="http://schemas.openxmlformats.org/officeDocument/2006/relationships/image" Target="../media/image25.png"/><Relationship Id="rId13" Type="http://schemas.openxmlformats.org/officeDocument/2006/relationships/image" Target="../media/image19.png"/><Relationship Id="rId1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5.png"/><Relationship Id="rId4" Type="http://schemas.openxmlformats.org/officeDocument/2006/relationships/image" Target="../media/image22.png"/><Relationship Id="rId9" Type="http://schemas.openxmlformats.org/officeDocument/2006/relationships/image" Target="../media/image14.png"/><Relationship Id="rId15" Type="http://schemas.openxmlformats.org/officeDocument/2006/relationships/image" Target="../media/image26.png"/><Relationship Id="rId14" Type="http://schemas.openxmlformats.org/officeDocument/2006/relationships/image" Target="../media/image31.png"/><Relationship Id="rId17" Type="http://schemas.openxmlformats.org/officeDocument/2006/relationships/image" Target="../media/image21.png"/><Relationship Id="rId16" Type="http://schemas.openxmlformats.org/officeDocument/2006/relationships/image" Target="../media/image36.png"/><Relationship Id="rId5" Type="http://schemas.openxmlformats.org/officeDocument/2006/relationships/image" Target="../media/image6.png"/><Relationship Id="rId6" Type="http://schemas.openxmlformats.org/officeDocument/2006/relationships/image" Target="../media/image20.png"/><Relationship Id="rId18" Type="http://schemas.openxmlformats.org/officeDocument/2006/relationships/image" Target="../media/image34.png"/><Relationship Id="rId7" Type="http://schemas.openxmlformats.org/officeDocument/2006/relationships/image" Target="../media/image15.png"/><Relationship Id="rId8" Type="http://schemas.openxmlformats.org/officeDocument/2006/relationships/image" Target="../media/image17.png"/></Relationships>
</file>

<file path=ppt/slides/_rels/slide3.xml.rels><?xml version="1.0" encoding="UTF-8" standalone="yes"?><Relationships xmlns="http://schemas.openxmlformats.org/package/2006/relationships"><Relationship Id="rId11" Type="http://schemas.openxmlformats.org/officeDocument/2006/relationships/image" Target="../media/image39.png"/><Relationship Id="rId10" Type="http://schemas.openxmlformats.org/officeDocument/2006/relationships/image" Target="../media/image29.png"/><Relationship Id="rId13" Type="http://schemas.openxmlformats.org/officeDocument/2006/relationships/image" Target="../media/image44.png"/><Relationship Id="rId1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2.png"/><Relationship Id="rId4" Type="http://schemas.openxmlformats.org/officeDocument/2006/relationships/image" Target="../media/image37.png"/><Relationship Id="rId9" Type="http://schemas.openxmlformats.org/officeDocument/2006/relationships/image" Target="../media/image38.png"/><Relationship Id="rId14" Type="http://schemas.openxmlformats.org/officeDocument/2006/relationships/image" Target="../media/image35.png"/><Relationship Id="rId5" Type="http://schemas.openxmlformats.org/officeDocument/2006/relationships/image" Target="../media/image41.png"/><Relationship Id="rId6" Type="http://schemas.openxmlformats.org/officeDocument/2006/relationships/image" Target="../media/image28.png"/><Relationship Id="rId7" Type="http://schemas.openxmlformats.org/officeDocument/2006/relationships/image" Target="../media/image30.png"/><Relationship Id="rId8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oogle Shape;84;p1"/>
          <p:cNvGrpSpPr/>
          <p:nvPr/>
        </p:nvGrpSpPr>
        <p:grpSpPr>
          <a:xfrm>
            <a:off x="246956" y="157405"/>
            <a:ext cx="6390237" cy="2076107"/>
            <a:chOff x="131266" y="157397"/>
            <a:chExt cx="6390237" cy="2053112"/>
          </a:xfrm>
        </p:grpSpPr>
        <p:grpSp>
          <p:nvGrpSpPr>
            <p:cNvPr id="85" name="Google Shape;85;p1"/>
            <p:cNvGrpSpPr/>
            <p:nvPr/>
          </p:nvGrpSpPr>
          <p:grpSpPr>
            <a:xfrm>
              <a:off x="131266" y="157397"/>
              <a:ext cx="6390237" cy="2053112"/>
              <a:chOff x="131266" y="157397"/>
              <a:chExt cx="6390237" cy="2053112"/>
            </a:xfrm>
          </p:grpSpPr>
          <p:grpSp>
            <p:nvGrpSpPr>
              <p:cNvPr id="86" name="Google Shape;86;p1"/>
              <p:cNvGrpSpPr/>
              <p:nvPr/>
            </p:nvGrpSpPr>
            <p:grpSpPr>
              <a:xfrm>
                <a:off x="131266" y="157397"/>
                <a:ext cx="6390237" cy="2053112"/>
                <a:chOff x="131266" y="157397"/>
                <a:chExt cx="6390237" cy="2053112"/>
              </a:xfrm>
            </p:grpSpPr>
            <p:grpSp>
              <p:nvGrpSpPr>
                <p:cNvPr id="87" name="Google Shape;87;p1"/>
                <p:cNvGrpSpPr/>
                <p:nvPr/>
              </p:nvGrpSpPr>
              <p:grpSpPr>
                <a:xfrm>
                  <a:off x="131266" y="157397"/>
                  <a:ext cx="6390237" cy="2053112"/>
                  <a:chOff x="131266" y="157397"/>
                  <a:chExt cx="6390237" cy="2053112"/>
                </a:xfrm>
              </p:grpSpPr>
              <p:grpSp>
                <p:nvGrpSpPr>
                  <p:cNvPr id="88" name="Google Shape;88;p1"/>
                  <p:cNvGrpSpPr/>
                  <p:nvPr/>
                </p:nvGrpSpPr>
                <p:grpSpPr>
                  <a:xfrm>
                    <a:off x="131266" y="157397"/>
                    <a:ext cx="6390237" cy="2053112"/>
                    <a:chOff x="131266" y="157397"/>
                    <a:chExt cx="6390237" cy="2053112"/>
                  </a:xfrm>
                </p:grpSpPr>
                <p:grpSp>
                  <p:nvGrpSpPr>
                    <p:cNvPr id="89" name="Google Shape;89;p1"/>
                    <p:cNvGrpSpPr/>
                    <p:nvPr/>
                  </p:nvGrpSpPr>
                  <p:grpSpPr>
                    <a:xfrm>
                      <a:off x="131266" y="157397"/>
                      <a:ext cx="6390237" cy="2053112"/>
                      <a:chOff x="131266" y="157397"/>
                      <a:chExt cx="6390237" cy="2053112"/>
                    </a:xfrm>
                  </p:grpSpPr>
                  <p:grpSp>
                    <p:nvGrpSpPr>
                      <p:cNvPr id="90" name="Google Shape;90;p1"/>
                      <p:cNvGrpSpPr/>
                      <p:nvPr/>
                    </p:nvGrpSpPr>
                    <p:grpSpPr>
                      <a:xfrm>
                        <a:off x="131266" y="157397"/>
                        <a:ext cx="6390237" cy="2053112"/>
                        <a:chOff x="160941" y="156687"/>
                        <a:chExt cx="6390237" cy="2053112"/>
                      </a:xfrm>
                    </p:grpSpPr>
                    <p:sp>
                      <p:nvSpPr>
                        <p:cNvPr id="91" name="Google Shape;91;p1"/>
                        <p:cNvSpPr/>
                        <p:nvPr/>
                      </p:nvSpPr>
                      <p:spPr>
                        <a:xfrm>
                          <a:off x="160941" y="156687"/>
                          <a:ext cx="773775" cy="2668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anchorCtr="0" anchor="t" bIns="34275" lIns="68550" spcFirstLastPara="1" rIns="68550" wrap="square" tIns="34275">
                          <a:spAutoFit/>
                        </a:bodyPr>
                        <a:lstStyle/>
                        <a:p>
                          <a:pPr indent="0" lvl="0" marL="0" marR="0" rtl="0" algn="ctr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b="0" i="0" lang="en-US" sz="1200" u="none" cap="none" strike="noStrike">
                              <a:solidFill>
                                <a:schemeClr val="dk1"/>
                              </a:solidFill>
                              <a:latin typeface="Calibri"/>
                              <a:ea typeface="Calibri"/>
                              <a:cs typeface="Calibri"/>
                              <a:sym typeface="Calibri"/>
                            </a:rPr>
                            <a:t>Patient 1</a:t>
                          </a:r>
                          <a:endParaRPr/>
                        </a:p>
                      </p:txBody>
                    </p:sp>
                    <p:pic>
                      <p:nvPicPr>
                        <p:cNvPr id="92" name="Google Shape;92;p1"/>
                        <p:cNvPicPr preferRelativeResize="0"/>
                        <p:nvPr/>
                      </p:nvPicPr>
                      <p:blipFill rotWithShape="1">
                        <a:blip r:embed="rId3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5004626" y="496569"/>
                          <a:ext cx="1546552" cy="171322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  <p:pic>
                      <p:nvPicPr>
                        <p:cNvPr id="93" name="Google Shape;93;p1"/>
                        <p:cNvPicPr preferRelativeResize="0"/>
                        <p:nvPr/>
                      </p:nvPicPr>
                      <p:blipFill rotWithShape="1">
                        <a:blip r:embed="rId4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3352311" y="496569"/>
                          <a:ext cx="1638479" cy="171322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  <p:pic>
                      <p:nvPicPr>
                        <p:cNvPr id="94" name="Google Shape;94;p1"/>
                        <p:cNvPicPr preferRelativeResize="0"/>
                        <p:nvPr/>
                      </p:nvPicPr>
                      <p:blipFill rotWithShape="1">
                        <a:blip r:embed="rId5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180336" y="496570"/>
                          <a:ext cx="1572457" cy="171322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  <p:pic>
                      <p:nvPicPr>
                        <p:cNvPr id="95" name="Google Shape;95;p1"/>
                        <p:cNvPicPr preferRelativeResize="0"/>
                        <p:nvPr/>
                      </p:nvPicPr>
                      <p:blipFill rotWithShape="1">
                        <a:blip r:embed="rId6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1766629" y="496569"/>
                          <a:ext cx="1571846" cy="171322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grpSp>
                  <p:sp>
                    <p:nvSpPr>
                      <p:cNvPr id="96" name="Google Shape;96;p1"/>
                      <p:cNvSpPr/>
                      <p:nvPr/>
                    </p:nvSpPr>
                    <p:spPr>
                      <a:xfrm>
                        <a:off x="428466" y="513751"/>
                        <a:ext cx="1064917" cy="100800"/>
                      </a:xfrm>
                      <a:prstGeom prst="rect">
                        <a:avLst/>
                      </a:prstGeom>
                      <a:solidFill>
                        <a:schemeClr val="lt1"/>
                      </a:solidFill>
                      <a:ln cap="flat" cmpd="sng" w="12700">
                        <a:solidFill>
                          <a:schemeClr val="lt1"/>
                        </a:solidFill>
                        <a:prstDash val="solid"/>
                        <a:miter lim="800000"/>
                        <a:headEnd len="sm" w="sm" type="none"/>
                        <a:tailEnd len="sm" w="sm" type="none"/>
                      </a:ln>
                    </p:spPr>
                    <p:txBody>
                      <a:bodyPr anchorCtr="0" anchor="ctr" bIns="45700" lIns="91425" spcFirstLastPara="1" rIns="91425" wrap="square" tIns="45700">
                        <a:noAutofit/>
                      </a:bodyPr>
                      <a:lstStyle/>
                      <a:p>
                        <a:pPr indent="0" lvl="0" marL="0" marR="0" rtl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1" i="0" lang="en-US" sz="4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Height in children from 0 to 22 years (cm)</a:t>
                        </a:r>
                        <a:endParaRPr/>
                      </a:p>
                      <a:p>
                        <a:pPr indent="0" lvl="0" marL="0" marR="0" rtl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1" i="0" lang="en-US" sz="4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Spanish transversal study 2010</a:t>
                        </a:r>
                        <a:endParaRPr b="1" i="0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97" name="Google Shape;97;p1"/>
                    <p:cNvSpPr/>
                    <p:nvPr/>
                  </p:nvSpPr>
                  <p:spPr>
                    <a:xfrm>
                      <a:off x="738826" y="2120113"/>
                      <a:ext cx="485522" cy="70165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ge (years)</a:t>
                      </a:r>
                      <a:endParaRPr b="1" i="0" sz="11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  <p:sp>
                  <p:nvSpPr>
                    <p:cNvPr id="98" name="Google Shape;98;p1"/>
                    <p:cNvSpPr/>
                    <p:nvPr/>
                  </p:nvSpPr>
                  <p:spPr>
                    <a:xfrm>
                      <a:off x="2351838" y="2122347"/>
                      <a:ext cx="485522" cy="70165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ge (years)</a:t>
                      </a:r>
                      <a:endParaRPr b="1" i="0" sz="11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99" name="Google Shape;99;p1"/>
                  <p:cNvSpPr/>
                  <p:nvPr/>
                </p:nvSpPr>
                <p:spPr>
                  <a:xfrm>
                    <a:off x="3954061" y="2120113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00" name="Google Shape;100;p1"/>
                  <p:cNvSpPr/>
                  <p:nvPr/>
                </p:nvSpPr>
                <p:spPr>
                  <a:xfrm>
                    <a:off x="5556284" y="2120112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101" name="Google Shape;101;p1"/>
                <p:cNvSpPr/>
                <p:nvPr/>
              </p:nvSpPr>
              <p:spPr>
                <a:xfrm>
                  <a:off x="2015586" y="522849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102" name="Google Shape;102;p1"/>
              <p:cNvSpPr/>
              <p:nvPr/>
            </p:nvSpPr>
            <p:spPr>
              <a:xfrm>
                <a:off x="3444772" y="522849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03" name="Google Shape;103;p1"/>
            <p:cNvSpPr/>
            <p:nvPr/>
          </p:nvSpPr>
          <p:spPr>
            <a:xfrm>
              <a:off x="5118210" y="518300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104" name="Google Shape;104;p1"/>
          <p:cNvGrpSpPr/>
          <p:nvPr/>
        </p:nvGrpSpPr>
        <p:grpSpPr>
          <a:xfrm>
            <a:off x="267600" y="2381146"/>
            <a:ext cx="6391824" cy="2017102"/>
            <a:chOff x="131266" y="2356508"/>
            <a:chExt cx="6414274" cy="1994761"/>
          </a:xfrm>
        </p:grpSpPr>
        <p:grpSp>
          <p:nvGrpSpPr>
            <p:cNvPr id="105" name="Google Shape;105;p1"/>
            <p:cNvGrpSpPr/>
            <p:nvPr/>
          </p:nvGrpSpPr>
          <p:grpSpPr>
            <a:xfrm>
              <a:off x="131266" y="2356508"/>
              <a:ext cx="6414274" cy="1994761"/>
              <a:chOff x="131266" y="2356508"/>
              <a:chExt cx="6414274" cy="1994761"/>
            </a:xfrm>
          </p:grpSpPr>
          <p:grpSp>
            <p:nvGrpSpPr>
              <p:cNvPr id="106" name="Google Shape;106;p1"/>
              <p:cNvGrpSpPr/>
              <p:nvPr/>
            </p:nvGrpSpPr>
            <p:grpSpPr>
              <a:xfrm>
                <a:off x="131266" y="2356508"/>
                <a:ext cx="6414274" cy="1994761"/>
                <a:chOff x="131266" y="2356508"/>
                <a:chExt cx="6414274" cy="1994761"/>
              </a:xfrm>
            </p:grpSpPr>
            <p:grpSp>
              <p:nvGrpSpPr>
                <p:cNvPr id="107" name="Google Shape;107;p1"/>
                <p:cNvGrpSpPr/>
                <p:nvPr/>
              </p:nvGrpSpPr>
              <p:grpSpPr>
                <a:xfrm>
                  <a:off x="131266" y="2356508"/>
                  <a:ext cx="6414274" cy="1994761"/>
                  <a:chOff x="131266" y="2356508"/>
                  <a:chExt cx="6414274" cy="1994761"/>
                </a:xfrm>
              </p:grpSpPr>
              <p:grpSp>
                <p:nvGrpSpPr>
                  <p:cNvPr id="108" name="Google Shape;108;p1"/>
                  <p:cNvGrpSpPr/>
                  <p:nvPr/>
                </p:nvGrpSpPr>
                <p:grpSpPr>
                  <a:xfrm>
                    <a:off x="131266" y="2356508"/>
                    <a:ext cx="6414274" cy="1994761"/>
                    <a:chOff x="131266" y="2356508"/>
                    <a:chExt cx="6414274" cy="1994761"/>
                  </a:xfrm>
                </p:grpSpPr>
                <p:grpSp>
                  <p:nvGrpSpPr>
                    <p:cNvPr id="109" name="Google Shape;109;p1"/>
                    <p:cNvGrpSpPr/>
                    <p:nvPr/>
                  </p:nvGrpSpPr>
                  <p:grpSpPr>
                    <a:xfrm>
                      <a:off x="131266" y="2356508"/>
                      <a:ext cx="6414274" cy="1994761"/>
                      <a:chOff x="136904" y="2428988"/>
                      <a:chExt cx="6414274" cy="1994761"/>
                    </a:xfrm>
                  </p:grpSpPr>
                  <p:pic>
                    <p:nvPicPr>
                      <p:cNvPr id="110" name="Google Shape;110;p1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779684" y="2708615"/>
                        <a:ext cx="1572627" cy="171322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11" name="Google Shape;111;p1"/>
                      <p:cNvPicPr preferRelativeResize="0"/>
                      <p:nvPr/>
                    </p:nvPicPr>
                    <p:blipFill rotWithShape="1">
                      <a:blip r:embed="rId8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78553" y="2708613"/>
                        <a:ext cx="1572625" cy="171322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12" name="Google Shape;112;p1"/>
                      <p:cNvPicPr preferRelativeResize="0"/>
                      <p:nvPr/>
                    </p:nvPicPr>
                    <p:blipFill rotWithShape="1">
                      <a:blip r:embed="rId9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379203" y="2708614"/>
                        <a:ext cx="1572458" cy="171322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13" name="Google Shape;113;p1"/>
                      <p:cNvPicPr preferRelativeResize="0"/>
                      <p:nvPr/>
                    </p:nvPicPr>
                    <p:blipFill rotWithShape="1">
                      <a:blip r:embed="rId10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0335" y="2710520"/>
                        <a:ext cx="1572457" cy="171322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114" name="Google Shape;114;p1"/>
                      <p:cNvSpPr/>
                      <p:nvPr/>
                    </p:nvSpPr>
                    <p:spPr>
                      <a:xfrm>
                        <a:off x="136904" y="2428988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2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115" name="Google Shape;115;p1"/>
                    <p:cNvSpPr/>
                    <p:nvPr/>
                  </p:nvSpPr>
                  <p:spPr>
                    <a:xfrm>
                      <a:off x="450615" y="2663610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116" name="Google Shape;116;p1"/>
                  <p:cNvSpPr/>
                  <p:nvPr/>
                </p:nvSpPr>
                <p:spPr>
                  <a:xfrm>
                    <a:off x="738826" y="4265424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17" name="Google Shape;117;p1"/>
                  <p:cNvSpPr/>
                  <p:nvPr/>
                </p:nvSpPr>
                <p:spPr>
                  <a:xfrm>
                    <a:off x="2416575" y="4262011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18" name="Google Shape;118;p1"/>
                  <p:cNvSpPr/>
                  <p:nvPr/>
                </p:nvSpPr>
                <p:spPr>
                  <a:xfrm>
                    <a:off x="3989202" y="426227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19" name="Google Shape;119;p1"/>
                  <p:cNvSpPr/>
                  <p:nvPr/>
                </p:nvSpPr>
                <p:spPr>
                  <a:xfrm>
                    <a:off x="5589573" y="4262269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120" name="Google Shape;120;p1"/>
                <p:cNvSpPr/>
                <p:nvPr/>
              </p:nvSpPr>
              <p:spPr>
                <a:xfrm>
                  <a:off x="2027900" y="2660621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121" name="Google Shape;121;p1"/>
              <p:cNvSpPr/>
              <p:nvPr/>
            </p:nvSpPr>
            <p:spPr>
              <a:xfrm>
                <a:off x="3448477" y="2660621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22" name="Google Shape;122;p1"/>
            <p:cNvSpPr/>
            <p:nvPr/>
          </p:nvSpPr>
          <p:spPr>
            <a:xfrm>
              <a:off x="5141118" y="2660879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123" name="Google Shape;123;p1"/>
          <p:cNvGrpSpPr/>
          <p:nvPr/>
        </p:nvGrpSpPr>
        <p:grpSpPr>
          <a:xfrm>
            <a:off x="198574" y="4545871"/>
            <a:ext cx="6460793" cy="2014373"/>
            <a:chOff x="62243" y="4497268"/>
            <a:chExt cx="6443396" cy="1992062"/>
          </a:xfrm>
        </p:grpSpPr>
        <p:grpSp>
          <p:nvGrpSpPr>
            <p:cNvPr id="124" name="Google Shape;124;p1"/>
            <p:cNvGrpSpPr/>
            <p:nvPr/>
          </p:nvGrpSpPr>
          <p:grpSpPr>
            <a:xfrm>
              <a:off x="62243" y="4497268"/>
              <a:ext cx="6443396" cy="1992062"/>
              <a:chOff x="62243" y="4497268"/>
              <a:chExt cx="6443396" cy="1992062"/>
            </a:xfrm>
          </p:grpSpPr>
          <p:grpSp>
            <p:nvGrpSpPr>
              <p:cNvPr id="125" name="Google Shape;125;p1"/>
              <p:cNvGrpSpPr/>
              <p:nvPr/>
            </p:nvGrpSpPr>
            <p:grpSpPr>
              <a:xfrm>
                <a:off x="62243" y="4497268"/>
                <a:ext cx="6443396" cy="1992062"/>
                <a:chOff x="62243" y="4497268"/>
                <a:chExt cx="6443396" cy="1992062"/>
              </a:xfrm>
            </p:grpSpPr>
            <p:grpSp>
              <p:nvGrpSpPr>
                <p:cNvPr id="126" name="Google Shape;126;p1"/>
                <p:cNvGrpSpPr/>
                <p:nvPr/>
              </p:nvGrpSpPr>
              <p:grpSpPr>
                <a:xfrm>
                  <a:off x="62243" y="4497268"/>
                  <a:ext cx="6443396" cy="1992062"/>
                  <a:chOff x="62243" y="4497268"/>
                  <a:chExt cx="6443396" cy="1992062"/>
                </a:xfrm>
              </p:grpSpPr>
              <p:grpSp>
                <p:nvGrpSpPr>
                  <p:cNvPr id="127" name="Google Shape;127;p1"/>
                  <p:cNvGrpSpPr/>
                  <p:nvPr/>
                </p:nvGrpSpPr>
                <p:grpSpPr>
                  <a:xfrm>
                    <a:off x="62243" y="4497268"/>
                    <a:ext cx="6443396" cy="1992062"/>
                    <a:chOff x="62243" y="4497268"/>
                    <a:chExt cx="6443396" cy="1992062"/>
                  </a:xfrm>
                </p:grpSpPr>
                <p:grpSp>
                  <p:nvGrpSpPr>
                    <p:cNvPr id="128" name="Google Shape;128;p1"/>
                    <p:cNvGrpSpPr/>
                    <p:nvPr/>
                  </p:nvGrpSpPr>
                  <p:grpSpPr>
                    <a:xfrm>
                      <a:off x="62243" y="4497268"/>
                      <a:ext cx="6443396" cy="1992062"/>
                      <a:chOff x="67054" y="4819581"/>
                      <a:chExt cx="6443396" cy="1992062"/>
                    </a:xfrm>
                  </p:grpSpPr>
                  <p:pic>
                    <p:nvPicPr>
                      <p:cNvPr id="129" name="Google Shape;129;p1"/>
                      <p:cNvPicPr preferRelativeResize="0"/>
                      <p:nvPr/>
                    </p:nvPicPr>
                    <p:blipFill rotWithShape="1">
                      <a:blip r:embed="rId11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0334" y="5097748"/>
                        <a:ext cx="1572457" cy="171389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30" name="Google Shape;130;p1"/>
                      <p:cNvPicPr preferRelativeResize="0"/>
                      <p:nvPr/>
                    </p:nvPicPr>
                    <p:blipFill rotWithShape="1">
                      <a:blip r:embed="rId12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766628" y="5097747"/>
                        <a:ext cx="1572457" cy="171389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31" name="Google Shape;131;p1"/>
                      <p:cNvPicPr preferRelativeResize="0"/>
                      <p:nvPr/>
                    </p:nvPicPr>
                    <p:blipFill rotWithShape="1">
                      <a:blip r:embed="rId13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352310" y="5097746"/>
                        <a:ext cx="1572457" cy="171389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32" name="Google Shape;132;p1"/>
                      <p:cNvPicPr preferRelativeResize="0"/>
                      <p:nvPr/>
                    </p:nvPicPr>
                    <p:blipFill rotWithShape="1">
                      <a:blip r:embed="rId14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37992" y="5097746"/>
                        <a:ext cx="1572458" cy="171389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133" name="Google Shape;133;p1"/>
                      <p:cNvSpPr/>
                      <p:nvPr/>
                    </p:nvSpPr>
                    <p:spPr>
                      <a:xfrm>
                        <a:off x="67054" y="4819581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3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134" name="Google Shape;134;p1"/>
                    <p:cNvSpPr/>
                    <p:nvPr/>
                  </p:nvSpPr>
                  <p:spPr>
                    <a:xfrm>
                      <a:off x="449130" y="4806196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135" name="Google Shape;135;p1"/>
                  <p:cNvSpPr/>
                  <p:nvPr/>
                </p:nvSpPr>
                <p:spPr>
                  <a:xfrm>
                    <a:off x="738826" y="6398938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36" name="Google Shape;136;p1"/>
                  <p:cNvSpPr/>
                  <p:nvPr/>
                </p:nvSpPr>
                <p:spPr>
                  <a:xfrm>
                    <a:off x="2351838" y="6399843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37" name="Google Shape;137;p1"/>
                  <p:cNvSpPr/>
                  <p:nvPr/>
                </p:nvSpPr>
                <p:spPr>
                  <a:xfrm>
                    <a:off x="3950745" y="6399311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38" name="Google Shape;138;p1"/>
                  <p:cNvSpPr/>
                  <p:nvPr/>
                </p:nvSpPr>
                <p:spPr>
                  <a:xfrm>
                    <a:off x="5556284" y="6398937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139" name="Google Shape;139;p1"/>
                <p:cNvSpPr/>
                <p:nvPr/>
              </p:nvSpPr>
              <p:spPr>
                <a:xfrm>
                  <a:off x="1986007" y="4806196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140" name="Google Shape;140;p1"/>
              <p:cNvSpPr/>
              <p:nvPr/>
            </p:nvSpPr>
            <p:spPr>
              <a:xfrm>
                <a:off x="3426853" y="4806196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41" name="Google Shape;141;p1"/>
            <p:cNvSpPr/>
            <p:nvPr/>
          </p:nvSpPr>
          <p:spPr>
            <a:xfrm>
              <a:off x="5078393" y="4806258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142" name="Google Shape;142;p1"/>
          <p:cNvGrpSpPr/>
          <p:nvPr/>
        </p:nvGrpSpPr>
        <p:grpSpPr>
          <a:xfrm>
            <a:off x="220826" y="6707914"/>
            <a:ext cx="6460952" cy="1972129"/>
            <a:chOff x="62243" y="6635329"/>
            <a:chExt cx="6395716" cy="1950286"/>
          </a:xfrm>
        </p:grpSpPr>
        <p:grpSp>
          <p:nvGrpSpPr>
            <p:cNvPr id="143" name="Google Shape;143;p1"/>
            <p:cNvGrpSpPr/>
            <p:nvPr/>
          </p:nvGrpSpPr>
          <p:grpSpPr>
            <a:xfrm>
              <a:off x="62243" y="6635329"/>
              <a:ext cx="6395716" cy="1950286"/>
              <a:chOff x="62243" y="6635329"/>
              <a:chExt cx="6395716" cy="1950286"/>
            </a:xfrm>
          </p:grpSpPr>
          <p:grpSp>
            <p:nvGrpSpPr>
              <p:cNvPr id="144" name="Google Shape;144;p1"/>
              <p:cNvGrpSpPr/>
              <p:nvPr/>
            </p:nvGrpSpPr>
            <p:grpSpPr>
              <a:xfrm>
                <a:off x="62243" y="6635329"/>
                <a:ext cx="6395716" cy="1950286"/>
                <a:chOff x="62243" y="6635329"/>
                <a:chExt cx="6395716" cy="1950286"/>
              </a:xfrm>
            </p:grpSpPr>
            <p:grpSp>
              <p:nvGrpSpPr>
                <p:cNvPr id="145" name="Google Shape;145;p1"/>
                <p:cNvGrpSpPr/>
                <p:nvPr/>
              </p:nvGrpSpPr>
              <p:grpSpPr>
                <a:xfrm>
                  <a:off x="62243" y="6635329"/>
                  <a:ext cx="6395716" cy="1950286"/>
                  <a:chOff x="62243" y="6635329"/>
                  <a:chExt cx="6395716" cy="1950286"/>
                </a:xfrm>
              </p:grpSpPr>
              <p:grpSp>
                <p:nvGrpSpPr>
                  <p:cNvPr id="146" name="Google Shape;146;p1"/>
                  <p:cNvGrpSpPr/>
                  <p:nvPr/>
                </p:nvGrpSpPr>
                <p:grpSpPr>
                  <a:xfrm>
                    <a:off x="62243" y="6635329"/>
                    <a:ext cx="6395716" cy="1950286"/>
                    <a:chOff x="62243" y="6635329"/>
                    <a:chExt cx="6395716" cy="1950286"/>
                  </a:xfrm>
                </p:grpSpPr>
                <p:grpSp>
                  <p:nvGrpSpPr>
                    <p:cNvPr id="147" name="Google Shape;147;p1"/>
                    <p:cNvGrpSpPr/>
                    <p:nvPr/>
                  </p:nvGrpSpPr>
                  <p:grpSpPr>
                    <a:xfrm>
                      <a:off x="62243" y="6635329"/>
                      <a:ext cx="6395716" cy="1950286"/>
                      <a:chOff x="62243" y="6635329"/>
                      <a:chExt cx="6395716" cy="1950286"/>
                    </a:xfrm>
                  </p:grpSpPr>
                  <p:pic>
                    <p:nvPicPr>
                      <p:cNvPr id="148" name="Google Shape;148;p1"/>
                      <p:cNvPicPr preferRelativeResize="0"/>
                      <p:nvPr/>
                    </p:nvPicPr>
                    <p:blipFill rotWithShape="1">
                      <a:blip r:embed="rId15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03857" y="6891723"/>
                        <a:ext cx="1554102" cy="169388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49" name="Google Shape;149;p1"/>
                      <p:cNvPicPr preferRelativeResize="0"/>
                      <p:nvPr/>
                    </p:nvPicPr>
                    <p:blipFill rotWithShape="1">
                      <a:blip r:embed="rId16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74697" y="6891727"/>
                        <a:ext cx="1554101" cy="16938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50" name="Google Shape;150;p1"/>
                      <p:cNvPicPr preferRelativeResize="0"/>
                      <p:nvPr/>
                    </p:nvPicPr>
                    <p:blipFill rotWithShape="1">
                      <a:blip r:embed="rId17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741415" y="6891725"/>
                        <a:ext cx="1554102" cy="169388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51" name="Google Shape;151;p1"/>
                      <p:cNvPicPr preferRelativeResize="0"/>
                      <p:nvPr/>
                    </p:nvPicPr>
                    <p:blipFill rotWithShape="1">
                      <a:blip r:embed="rId18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322636" y="6891724"/>
                        <a:ext cx="1554102" cy="169388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152" name="Google Shape;152;p1"/>
                      <p:cNvSpPr/>
                      <p:nvPr/>
                    </p:nvSpPr>
                    <p:spPr>
                      <a:xfrm>
                        <a:off x="62243" y="6635329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4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153" name="Google Shape;153;p1"/>
                    <p:cNvSpPr/>
                    <p:nvPr/>
                  </p:nvSpPr>
                  <p:spPr>
                    <a:xfrm>
                      <a:off x="449129" y="6919970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154" name="Google Shape;154;p1"/>
                  <p:cNvSpPr/>
                  <p:nvPr/>
                </p:nvSpPr>
                <p:spPr>
                  <a:xfrm>
                    <a:off x="738826" y="8496127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55" name="Google Shape;155;p1"/>
                  <p:cNvSpPr/>
                  <p:nvPr/>
                </p:nvSpPr>
                <p:spPr>
                  <a:xfrm>
                    <a:off x="2317598" y="8496126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56" name="Google Shape;156;p1"/>
                  <p:cNvSpPr/>
                  <p:nvPr/>
                </p:nvSpPr>
                <p:spPr>
                  <a:xfrm>
                    <a:off x="3899114" y="8496125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57" name="Google Shape;157;p1"/>
                  <p:cNvSpPr/>
                  <p:nvPr/>
                </p:nvSpPr>
                <p:spPr>
                  <a:xfrm>
                    <a:off x="5539374" y="8496124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158" name="Google Shape;158;p1"/>
                <p:cNvSpPr/>
                <p:nvPr/>
              </p:nvSpPr>
              <p:spPr>
                <a:xfrm>
                  <a:off x="1993258" y="6919056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159" name="Google Shape;159;p1"/>
              <p:cNvSpPr/>
              <p:nvPr/>
            </p:nvSpPr>
            <p:spPr>
              <a:xfrm>
                <a:off x="3384665" y="6919056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60" name="Google Shape;160;p1"/>
            <p:cNvSpPr/>
            <p:nvPr/>
          </p:nvSpPr>
          <p:spPr>
            <a:xfrm>
              <a:off x="5039891" y="6920852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64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p2"/>
          <p:cNvSpPr/>
          <p:nvPr/>
        </p:nvSpPr>
        <p:spPr>
          <a:xfrm>
            <a:off x="3599669" y="6709322"/>
            <a:ext cx="1430100" cy="132600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ody mass index in children from 0 to 22 years (kg/m2)</a:t>
            </a:r>
            <a:endParaRPr/>
          </a:p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anish transversal study 2010</a:t>
            </a:r>
            <a:endParaRPr b="1" i="0" sz="4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6" name="Google Shape;166;p2"/>
          <p:cNvSpPr/>
          <p:nvPr/>
        </p:nvSpPr>
        <p:spPr>
          <a:xfrm>
            <a:off x="3599668" y="2513711"/>
            <a:ext cx="1430100" cy="132600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ody mass index in children from 0 to 22 years (kg/m2)</a:t>
            </a:r>
            <a:endParaRPr/>
          </a:p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anish transversal study 2010</a:t>
            </a:r>
            <a:endParaRPr b="1" i="0" sz="4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67" name="Google Shape;167;p2"/>
          <p:cNvGrpSpPr/>
          <p:nvPr/>
        </p:nvGrpSpPr>
        <p:grpSpPr>
          <a:xfrm>
            <a:off x="217523" y="6424943"/>
            <a:ext cx="6431484" cy="1983387"/>
            <a:chOff x="131266" y="6424943"/>
            <a:chExt cx="6431484" cy="1983387"/>
          </a:xfrm>
        </p:grpSpPr>
        <p:grpSp>
          <p:nvGrpSpPr>
            <p:cNvPr id="168" name="Google Shape;168;p2"/>
            <p:cNvGrpSpPr/>
            <p:nvPr/>
          </p:nvGrpSpPr>
          <p:grpSpPr>
            <a:xfrm>
              <a:off x="131266" y="6424943"/>
              <a:ext cx="6431484" cy="1983387"/>
              <a:chOff x="131266" y="6424943"/>
              <a:chExt cx="6431484" cy="1983387"/>
            </a:xfrm>
          </p:grpSpPr>
          <p:grpSp>
            <p:nvGrpSpPr>
              <p:cNvPr id="169" name="Google Shape;169;p2"/>
              <p:cNvGrpSpPr/>
              <p:nvPr/>
            </p:nvGrpSpPr>
            <p:grpSpPr>
              <a:xfrm>
                <a:off x="131266" y="6424943"/>
                <a:ext cx="6431484" cy="1983387"/>
                <a:chOff x="131266" y="6424943"/>
                <a:chExt cx="6431484" cy="1983387"/>
              </a:xfrm>
            </p:grpSpPr>
            <p:grpSp>
              <p:nvGrpSpPr>
                <p:cNvPr id="170" name="Google Shape;170;p2"/>
                <p:cNvGrpSpPr/>
                <p:nvPr/>
              </p:nvGrpSpPr>
              <p:grpSpPr>
                <a:xfrm>
                  <a:off x="131266" y="6424943"/>
                  <a:ext cx="6431484" cy="1983387"/>
                  <a:chOff x="131266" y="6424943"/>
                  <a:chExt cx="6431484" cy="1983387"/>
                </a:xfrm>
              </p:grpSpPr>
              <p:grpSp>
                <p:nvGrpSpPr>
                  <p:cNvPr id="171" name="Google Shape;171;p2"/>
                  <p:cNvGrpSpPr/>
                  <p:nvPr/>
                </p:nvGrpSpPr>
                <p:grpSpPr>
                  <a:xfrm>
                    <a:off x="131266" y="6424943"/>
                    <a:ext cx="6431484" cy="1983387"/>
                    <a:chOff x="131266" y="6424943"/>
                    <a:chExt cx="6431484" cy="1983387"/>
                  </a:xfrm>
                </p:grpSpPr>
                <p:grpSp>
                  <p:nvGrpSpPr>
                    <p:cNvPr id="172" name="Google Shape;172;p2"/>
                    <p:cNvGrpSpPr/>
                    <p:nvPr/>
                  </p:nvGrpSpPr>
                  <p:grpSpPr>
                    <a:xfrm>
                      <a:off x="131266" y="6424943"/>
                      <a:ext cx="6431484" cy="1983387"/>
                      <a:chOff x="131266" y="6424943"/>
                      <a:chExt cx="6431484" cy="1983387"/>
                    </a:xfrm>
                  </p:grpSpPr>
                  <p:pic>
                    <p:nvPicPr>
                      <p:cNvPr id="173" name="Google Shape;173;p2"/>
                      <p:cNvPicPr preferRelativeResize="0"/>
                      <p:nvPr/>
                    </p:nvPicPr>
                    <p:blipFill rotWithShape="1">
                      <a:blip r:embed="rId3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12610" y="6698476"/>
                        <a:ext cx="1569526" cy="170985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74" name="Google Shape;174;p2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93816" y="6698476"/>
                        <a:ext cx="1568934" cy="170920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75" name="Google Shape;175;p2"/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400520" y="6691781"/>
                        <a:ext cx="1574912" cy="17159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176" name="Google Shape;176;p2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224639" y="6698476"/>
                        <a:ext cx="1568767" cy="170920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177" name="Google Shape;177;p2"/>
                      <p:cNvSpPr/>
                      <p:nvPr/>
                    </p:nvSpPr>
                    <p:spPr>
                      <a:xfrm>
                        <a:off x="131266" y="6424943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8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178" name="Google Shape;178;p2"/>
                    <p:cNvSpPr/>
                    <p:nvPr/>
                  </p:nvSpPr>
                  <p:spPr>
                    <a:xfrm>
                      <a:off x="476595" y="6727518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179" name="Google Shape;179;p2"/>
                  <p:cNvSpPr/>
                  <p:nvPr/>
                </p:nvSpPr>
                <p:spPr>
                  <a:xfrm>
                    <a:off x="793733" y="831764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80" name="Google Shape;180;p2"/>
                  <p:cNvSpPr/>
                  <p:nvPr/>
                </p:nvSpPr>
                <p:spPr>
                  <a:xfrm>
                    <a:off x="2398002" y="8317639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81" name="Google Shape;181;p2"/>
                  <p:cNvSpPr/>
                  <p:nvPr/>
                </p:nvSpPr>
                <p:spPr>
                  <a:xfrm>
                    <a:off x="3985673" y="8317639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182" name="Google Shape;182;p2"/>
                  <p:cNvSpPr/>
                  <p:nvPr/>
                </p:nvSpPr>
                <p:spPr>
                  <a:xfrm>
                    <a:off x="5589942" y="8317638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183" name="Google Shape;183;p2"/>
                <p:cNvSpPr/>
                <p:nvPr/>
              </p:nvSpPr>
              <p:spPr>
                <a:xfrm>
                  <a:off x="2110647" y="6727518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184" name="Google Shape;184;p2"/>
              <p:cNvSpPr/>
              <p:nvPr/>
            </p:nvSpPr>
            <p:spPr>
              <a:xfrm>
                <a:off x="5170097" y="6727518"/>
                <a:ext cx="1282034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ephalic circumference in children (cm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85" name="Google Shape;185;p2"/>
            <p:cNvSpPr/>
            <p:nvPr/>
          </p:nvSpPr>
          <p:spPr>
            <a:xfrm>
              <a:off x="3481435" y="6718420"/>
              <a:ext cx="1430043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ody mass index in children from 0 to 22 years (kg/m2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186" name="Google Shape;186;p2"/>
          <p:cNvGrpSpPr/>
          <p:nvPr/>
        </p:nvGrpSpPr>
        <p:grpSpPr>
          <a:xfrm>
            <a:off x="208993" y="4329556"/>
            <a:ext cx="6431841" cy="1977538"/>
            <a:chOff x="122736" y="4329556"/>
            <a:chExt cx="6431841" cy="1977538"/>
          </a:xfrm>
        </p:grpSpPr>
        <p:grpSp>
          <p:nvGrpSpPr>
            <p:cNvPr id="187" name="Google Shape;187;p2"/>
            <p:cNvGrpSpPr/>
            <p:nvPr/>
          </p:nvGrpSpPr>
          <p:grpSpPr>
            <a:xfrm>
              <a:off x="122736" y="4329556"/>
              <a:ext cx="6431841" cy="1977538"/>
              <a:chOff x="122736" y="4329556"/>
              <a:chExt cx="6431841" cy="1977538"/>
            </a:xfrm>
          </p:grpSpPr>
          <p:grpSp>
            <p:nvGrpSpPr>
              <p:cNvPr id="188" name="Google Shape;188;p2"/>
              <p:cNvGrpSpPr/>
              <p:nvPr/>
            </p:nvGrpSpPr>
            <p:grpSpPr>
              <a:xfrm>
                <a:off x="122736" y="4329556"/>
                <a:ext cx="6431841" cy="1977538"/>
                <a:chOff x="122736" y="4329556"/>
                <a:chExt cx="6431841" cy="1977538"/>
              </a:xfrm>
            </p:grpSpPr>
            <p:grpSp>
              <p:nvGrpSpPr>
                <p:cNvPr id="189" name="Google Shape;189;p2"/>
                <p:cNvGrpSpPr/>
                <p:nvPr/>
              </p:nvGrpSpPr>
              <p:grpSpPr>
                <a:xfrm>
                  <a:off x="122736" y="4329556"/>
                  <a:ext cx="6431841" cy="1977538"/>
                  <a:chOff x="122736" y="4329556"/>
                  <a:chExt cx="6431841" cy="1977538"/>
                </a:xfrm>
              </p:grpSpPr>
              <p:grpSp>
                <p:nvGrpSpPr>
                  <p:cNvPr id="190" name="Google Shape;190;p2"/>
                  <p:cNvGrpSpPr/>
                  <p:nvPr/>
                </p:nvGrpSpPr>
                <p:grpSpPr>
                  <a:xfrm>
                    <a:off x="122736" y="4329556"/>
                    <a:ext cx="6431841" cy="1977538"/>
                    <a:chOff x="122736" y="4329556"/>
                    <a:chExt cx="6431841" cy="1977538"/>
                  </a:xfrm>
                </p:grpSpPr>
                <p:grpSp>
                  <p:nvGrpSpPr>
                    <p:cNvPr id="191" name="Google Shape;191;p2"/>
                    <p:cNvGrpSpPr/>
                    <p:nvPr/>
                  </p:nvGrpSpPr>
                  <p:grpSpPr>
                    <a:xfrm>
                      <a:off x="122736" y="4329556"/>
                      <a:ext cx="6431841" cy="1977538"/>
                      <a:chOff x="122736" y="4329556"/>
                      <a:chExt cx="6431841" cy="1977538"/>
                    </a:xfrm>
                  </p:grpSpPr>
                  <p:grpSp>
                    <p:nvGrpSpPr>
                      <p:cNvPr id="192" name="Google Shape;192;p2"/>
                      <p:cNvGrpSpPr/>
                      <p:nvPr/>
                    </p:nvGrpSpPr>
                    <p:grpSpPr>
                      <a:xfrm>
                        <a:off x="122736" y="4329556"/>
                        <a:ext cx="6431841" cy="1977538"/>
                        <a:chOff x="122736" y="4204653"/>
                        <a:chExt cx="6431841" cy="1977538"/>
                      </a:xfrm>
                    </p:grpSpPr>
                    <p:pic>
                      <p:nvPicPr>
                        <p:cNvPr id="193" name="Google Shape;193;p2"/>
                        <p:cNvPicPr preferRelativeResize="0"/>
                        <p:nvPr/>
                      </p:nvPicPr>
                      <p:blipFill rotWithShape="1">
                        <a:blip r:embed="rId7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1812610" y="4471491"/>
                          <a:ext cx="1569526" cy="17107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  <p:pic>
                      <p:nvPicPr>
                        <p:cNvPr id="194" name="Google Shape;194;p2"/>
                        <p:cNvPicPr preferRelativeResize="0"/>
                        <p:nvPr/>
                      </p:nvPicPr>
                      <p:blipFill rotWithShape="1">
                        <a:blip r:embed="rId8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4986405" y="4471489"/>
                          <a:ext cx="1568172" cy="170922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  <p:pic>
                      <p:nvPicPr>
                        <p:cNvPr id="195" name="Google Shape;195;p2"/>
                        <p:cNvPicPr preferRelativeResize="0"/>
                        <p:nvPr/>
                      </p:nvPicPr>
                      <p:blipFill rotWithShape="1">
                        <a:blip r:embed="rId9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3400520" y="4471490"/>
                          <a:ext cx="1568171" cy="170922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  <p:pic>
                      <p:nvPicPr>
                        <p:cNvPr id="196" name="Google Shape;196;p2"/>
                        <p:cNvPicPr preferRelativeResize="0"/>
                        <p:nvPr/>
                      </p:nvPicPr>
                      <p:blipFill rotWithShape="1">
                        <a:blip r:embed="rId10">
                          <a:alphaModFix/>
                        </a:blip>
                        <a:srcRect b="0" l="0" r="0" t="0"/>
                        <a:stretch/>
                      </p:blipFill>
                      <p:spPr>
                        <a:xfrm>
                          <a:off x="224640" y="4471505"/>
                          <a:ext cx="1568767" cy="170920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  <p:sp>
                      <p:nvSpPr>
                        <p:cNvPr id="197" name="Google Shape;197;p2"/>
                        <p:cNvSpPr/>
                        <p:nvPr/>
                      </p:nvSpPr>
                      <p:spPr>
                        <a:xfrm>
                          <a:off x="122736" y="4204653"/>
                          <a:ext cx="773775" cy="2668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anchorCtr="0" anchor="t" bIns="34275" lIns="68550" spcFirstLastPara="1" rIns="68550" wrap="square" tIns="34275">
                          <a:spAutoFit/>
                        </a:bodyPr>
                        <a:lstStyle/>
                        <a:p>
                          <a:pPr indent="0" lvl="0" marL="0" marR="0" rtl="0" algn="ctr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None/>
                          </a:pPr>
                          <a:r>
                            <a:rPr b="0" i="0" lang="en-US" sz="1200" u="none" cap="none" strike="noStrike">
                              <a:solidFill>
                                <a:schemeClr val="dk1"/>
                              </a:solidFill>
                              <a:latin typeface="Calibri"/>
                              <a:ea typeface="Calibri"/>
                              <a:cs typeface="Calibri"/>
                              <a:sym typeface="Calibri"/>
                            </a:rPr>
                            <a:t>Patient 7</a:t>
                          </a:r>
                          <a:endParaRPr b="0" i="0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endParaRPr>
                        </a:p>
                      </p:txBody>
                    </p:sp>
                  </p:grpSp>
                  <p:sp>
                    <p:nvSpPr>
                      <p:cNvPr id="198" name="Google Shape;198;p2"/>
                      <p:cNvSpPr/>
                      <p:nvPr/>
                    </p:nvSpPr>
                    <p:spPr>
                      <a:xfrm>
                        <a:off x="504036" y="4621424"/>
                        <a:ext cx="1064917" cy="100800"/>
                      </a:xfrm>
                      <a:prstGeom prst="rect">
                        <a:avLst/>
                      </a:prstGeom>
                      <a:solidFill>
                        <a:schemeClr val="lt1"/>
                      </a:solidFill>
                      <a:ln cap="flat" cmpd="sng" w="12700">
                        <a:solidFill>
                          <a:schemeClr val="lt1"/>
                        </a:solidFill>
                        <a:prstDash val="solid"/>
                        <a:miter lim="800000"/>
                        <a:headEnd len="sm" w="sm" type="none"/>
                        <a:tailEnd len="sm" w="sm" type="none"/>
                      </a:ln>
                    </p:spPr>
                    <p:txBody>
                      <a:bodyPr anchorCtr="0" anchor="ctr" bIns="45700" lIns="91425" spcFirstLastPara="1" rIns="91425" wrap="square" tIns="45700">
                        <a:noAutofit/>
                      </a:bodyPr>
                      <a:lstStyle/>
                      <a:p>
                        <a:pPr indent="0" lvl="0" marL="0" marR="0" rtl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1" i="0" lang="en-US" sz="4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Height in children from 0 to 22 years (cm)</a:t>
                        </a:r>
                        <a:endParaRPr/>
                      </a:p>
                      <a:p>
                        <a:pPr indent="0" lvl="0" marL="0" marR="0" rtl="0" algn="ctr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1" i="0" lang="en-US" sz="4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Spanish transversal study 2010</a:t>
                        </a:r>
                        <a:endParaRPr b="1" i="0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199" name="Google Shape;199;p2"/>
                    <p:cNvSpPr/>
                    <p:nvPr/>
                  </p:nvSpPr>
                  <p:spPr>
                    <a:xfrm>
                      <a:off x="793733" y="6215571"/>
                      <a:ext cx="485522" cy="70165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ge (years)</a:t>
                      </a:r>
                      <a:endParaRPr b="1" i="0" sz="11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  <p:sp>
                  <p:nvSpPr>
                    <p:cNvPr id="200" name="Google Shape;200;p2"/>
                    <p:cNvSpPr/>
                    <p:nvPr/>
                  </p:nvSpPr>
                  <p:spPr>
                    <a:xfrm>
                      <a:off x="2398002" y="6215830"/>
                      <a:ext cx="485522" cy="70165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ge (years)</a:t>
                      </a:r>
                      <a:endParaRPr b="1" i="0" sz="11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  <p:sp>
                  <p:nvSpPr>
                    <p:cNvPr id="201" name="Google Shape;201;p2"/>
                    <p:cNvSpPr/>
                    <p:nvPr/>
                  </p:nvSpPr>
                  <p:spPr>
                    <a:xfrm>
                      <a:off x="3985673" y="6215571"/>
                      <a:ext cx="485522" cy="70165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ge (years)</a:t>
                      </a:r>
                      <a:endParaRPr b="1" i="0" sz="11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  <p:sp>
                  <p:nvSpPr>
                    <p:cNvPr id="202" name="Google Shape;202;p2"/>
                    <p:cNvSpPr/>
                    <p:nvPr/>
                  </p:nvSpPr>
                  <p:spPr>
                    <a:xfrm>
                      <a:off x="5589942" y="6215571"/>
                      <a:ext cx="485522" cy="70165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ge (years)</a:t>
                      </a:r>
                      <a:endParaRPr b="1" i="0" sz="11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203" name="Google Shape;203;p2"/>
                  <p:cNvSpPr/>
                  <p:nvPr/>
                </p:nvSpPr>
                <p:spPr>
                  <a:xfrm>
                    <a:off x="2072803" y="4610270"/>
                    <a:ext cx="1064917" cy="132682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Height in children from 0 to 22 years (cm)</a:t>
                    </a:r>
                    <a:endParaRPr/>
                  </a:p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Spanish transversal study 2010</a:t>
                    </a:r>
                    <a:endParaRPr b="1" i="0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204" name="Google Shape;204;p2"/>
                <p:cNvSpPr/>
                <p:nvPr/>
              </p:nvSpPr>
              <p:spPr>
                <a:xfrm>
                  <a:off x="2064914" y="4628466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205" name="Google Shape;205;p2"/>
              <p:cNvSpPr/>
              <p:nvPr/>
            </p:nvSpPr>
            <p:spPr>
              <a:xfrm>
                <a:off x="3469583" y="4619368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206" name="Google Shape;206;p2"/>
            <p:cNvSpPr/>
            <p:nvPr/>
          </p:nvSpPr>
          <p:spPr>
            <a:xfrm>
              <a:off x="5180485" y="4619368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207" name="Google Shape;207;p2"/>
          <p:cNvGrpSpPr/>
          <p:nvPr/>
        </p:nvGrpSpPr>
        <p:grpSpPr>
          <a:xfrm>
            <a:off x="208993" y="2256770"/>
            <a:ext cx="6436853" cy="1954938"/>
            <a:chOff x="122736" y="2256770"/>
            <a:chExt cx="6436853" cy="1954938"/>
          </a:xfrm>
        </p:grpSpPr>
        <p:grpSp>
          <p:nvGrpSpPr>
            <p:cNvPr id="208" name="Google Shape;208;p2"/>
            <p:cNvGrpSpPr/>
            <p:nvPr/>
          </p:nvGrpSpPr>
          <p:grpSpPr>
            <a:xfrm>
              <a:off x="122736" y="2256770"/>
              <a:ext cx="6436853" cy="1954938"/>
              <a:chOff x="122736" y="2256770"/>
              <a:chExt cx="6436853" cy="1954938"/>
            </a:xfrm>
          </p:grpSpPr>
          <p:grpSp>
            <p:nvGrpSpPr>
              <p:cNvPr id="209" name="Google Shape;209;p2"/>
              <p:cNvGrpSpPr/>
              <p:nvPr/>
            </p:nvGrpSpPr>
            <p:grpSpPr>
              <a:xfrm>
                <a:off x="122736" y="2256770"/>
                <a:ext cx="6436853" cy="1954938"/>
                <a:chOff x="122736" y="2256770"/>
                <a:chExt cx="6436853" cy="1954938"/>
              </a:xfrm>
            </p:grpSpPr>
            <p:grpSp>
              <p:nvGrpSpPr>
                <p:cNvPr id="210" name="Google Shape;210;p2"/>
                <p:cNvGrpSpPr/>
                <p:nvPr/>
              </p:nvGrpSpPr>
              <p:grpSpPr>
                <a:xfrm>
                  <a:off x="122736" y="2256770"/>
                  <a:ext cx="6436853" cy="1954938"/>
                  <a:chOff x="122736" y="2256770"/>
                  <a:chExt cx="6436853" cy="1954938"/>
                </a:xfrm>
              </p:grpSpPr>
              <p:grpSp>
                <p:nvGrpSpPr>
                  <p:cNvPr id="211" name="Google Shape;211;p2"/>
                  <p:cNvGrpSpPr/>
                  <p:nvPr/>
                </p:nvGrpSpPr>
                <p:grpSpPr>
                  <a:xfrm>
                    <a:off x="122736" y="2256770"/>
                    <a:ext cx="6436853" cy="1954938"/>
                    <a:chOff x="122736" y="2256770"/>
                    <a:chExt cx="6436853" cy="1954938"/>
                  </a:xfrm>
                </p:grpSpPr>
                <p:grpSp>
                  <p:nvGrpSpPr>
                    <p:cNvPr id="212" name="Google Shape;212;p2"/>
                    <p:cNvGrpSpPr/>
                    <p:nvPr/>
                  </p:nvGrpSpPr>
                  <p:grpSpPr>
                    <a:xfrm>
                      <a:off x="122736" y="2256770"/>
                      <a:ext cx="6436853" cy="1954938"/>
                      <a:chOff x="131265" y="2368419"/>
                      <a:chExt cx="6436853" cy="1954938"/>
                    </a:xfrm>
                  </p:grpSpPr>
                  <p:pic>
                    <p:nvPicPr>
                      <p:cNvPr id="213" name="Google Shape;213;p2"/>
                      <p:cNvPicPr preferRelativeResize="0"/>
                      <p:nvPr/>
                    </p:nvPicPr>
                    <p:blipFill rotWithShape="1">
                      <a:blip r:embed="rId11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411135" y="2614038"/>
                        <a:ext cx="1568256" cy="170931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14" name="Google Shape;214;p2"/>
                      <p:cNvPicPr preferRelativeResize="0"/>
                      <p:nvPr/>
                    </p:nvPicPr>
                    <p:blipFill rotWithShape="1">
                      <a:blip r:embed="rId12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22408" y="2614039"/>
                        <a:ext cx="1568257" cy="170931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15" name="Google Shape;215;p2"/>
                      <p:cNvPicPr preferRelativeResize="0"/>
                      <p:nvPr/>
                    </p:nvPicPr>
                    <p:blipFill rotWithShape="1">
                      <a:blip r:embed="rId13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233681" y="2614041"/>
                        <a:ext cx="1568256" cy="170931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16" name="Google Shape;216;p2"/>
                      <p:cNvPicPr preferRelativeResize="0"/>
                      <p:nvPr/>
                    </p:nvPicPr>
                    <p:blipFill rotWithShape="1">
                      <a:blip r:embed="rId14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99861" y="2614037"/>
                        <a:ext cx="1568257" cy="170931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217" name="Google Shape;217;p2"/>
                      <p:cNvSpPr/>
                      <p:nvPr/>
                    </p:nvSpPr>
                    <p:spPr>
                      <a:xfrm>
                        <a:off x="131265" y="2368419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6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218" name="Google Shape;218;p2"/>
                    <p:cNvSpPr/>
                    <p:nvPr/>
                  </p:nvSpPr>
                  <p:spPr>
                    <a:xfrm>
                      <a:off x="509622" y="2530260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219" name="Google Shape;219;p2"/>
                  <p:cNvSpPr/>
                  <p:nvPr/>
                </p:nvSpPr>
                <p:spPr>
                  <a:xfrm>
                    <a:off x="793733" y="411748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20" name="Google Shape;220;p2"/>
                  <p:cNvSpPr/>
                  <p:nvPr/>
                </p:nvSpPr>
                <p:spPr>
                  <a:xfrm>
                    <a:off x="2400561" y="411748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21" name="Google Shape;221;p2"/>
                  <p:cNvSpPr/>
                  <p:nvPr/>
                </p:nvSpPr>
                <p:spPr>
                  <a:xfrm>
                    <a:off x="3941844" y="4117479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22" name="Google Shape;222;p2"/>
                  <p:cNvSpPr/>
                  <p:nvPr/>
                </p:nvSpPr>
                <p:spPr>
                  <a:xfrm>
                    <a:off x="5568353" y="4117478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223" name="Google Shape;223;p2"/>
                <p:cNvSpPr/>
                <p:nvPr/>
              </p:nvSpPr>
              <p:spPr>
                <a:xfrm>
                  <a:off x="2116132" y="2530260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224" name="Google Shape;224;p2"/>
              <p:cNvSpPr/>
              <p:nvPr/>
            </p:nvSpPr>
            <p:spPr>
              <a:xfrm>
                <a:off x="5191686" y="2534809"/>
                <a:ext cx="1282034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ephalic circumference in children (cm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225" name="Google Shape;225;p2"/>
            <p:cNvSpPr/>
            <p:nvPr/>
          </p:nvSpPr>
          <p:spPr>
            <a:xfrm>
              <a:off x="3533880" y="2530260"/>
              <a:ext cx="1430100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ody mass index in children from 0 to 22 years (kg/m2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226" name="Google Shape;226;p2"/>
          <p:cNvGrpSpPr/>
          <p:nvPr/>
        </p:nvGrpSpPr>
        <p:grpSpPr>
          <a:xfrm>
            <a:off x="217523" y="157397"/>
            <a:ext cx="6428323" cy="1981525"/>
            <a:chOff x="131266" y="157397"/>
            <a:chExt cx="6428323" cy="1981525"/>
          </a:xfrm>
        </p:grpSpPr>
        <p:grpSp>
          <p:nvGrpSpPr>
            <p:cNvPr id="227" name="Google Shape;227;p2"/>
            <p:cNvGrpSpPr/>
            <p:nvPr/>
          </p:nvGrpSpPr>
          <p:grpSpPr>
            <a:xfrm>
              <a:off x="131266" y="157397"/>
              <a:ext cx="6428323" cy="1981525"/>
              <a:chOff x="131266" y="157397"/>
              <a:chExt cx="6428323" cy="1981525"/>
            </a:xfrm>
          </p:grpSpPr>
          <p:grpSp>
            <p:nvGrpSpPr>
              <p:cNvPr id="228" name="Google Shape;228;p2"/>
              <p:cNvGrpSpPr/>
              <p:nvPr/>
            </p:nvGrpSpPr>
            <p:grpSpPr>
              <a:xfrm>
                <a:off x="131266" y="157397"/>
                <a:ext cx="6428323" cy="1981525"/>
                <a:chOff x="131266" y="157397"/>
                <a:chExt cx="6428323" cy="1981525"/>
              </a:xfrm>
            </p:grpSpPr>
            <p:grpSp>
              <p:nvGrpSpPr>
                <p:cNvPr id="229" name="Google Shape;229;p2"/>
                <p:cNvGrpSpPr/>
                <p:nvPr/>
              </p:nvGrpSpPr>
              <p:grpSpPr>
                <a:xfrm>
                  <a:off x="131266" y="157397"/>
                  <a:ext cx="6428323" cy="1981525"/>
                  <a:chOff x="131266" y="157397"/>
                  <a:chExt cx="6428323" cy="1981525"/>
                </a:xfrm>
              </p:grpSpPr>
              <p:grpSp>
                <p:nvGrpSpPr>
                  <p:cNvPr id="230" name="Google Shape;230;p2"/>
                  <p:cNvGrpSpPr/>
                  <p:nvPr/>
                </p:nvGrpSpPr>
                <p:grpSpPr>
                  <a:xfrm>
                    <a:off x="131266" y="157397"/>
                    <a:ext cx="6428323" cy="1981525"/>
                    <a:chOff x="131266" y="157397"/>
                    <a:chExt cx="6428323" cy="1981525"/>
                  </a:xfrm>
                </p:grpSpPr>
                <p:grpSp>
                  <p:nvGrpSpPr>
                    <p:cNvPr id="231" name="Google Shape;231;p2"/>
                    <p:cNvGrpSpPr/>
                    <p:nvPr/>
                  </p:nvGrpSpPr>
                  <p:grpSpPr>
                    <a:xfrm>
                      <a:off x="131266" y="157397"/>
                      <a:ext cx="6428323" cy="1981525"/>
                      <a:chOff x="131266" y="157397"/>
                      <a:chExt cx="6428323" cy="1981525"/>
                    </a:xfrm>
                  </p:grpSpPr>
                  <p:pic>
                    <p:nvPicPr>
                      <p:cNvPr id="232" name="Google Shape;232;p2"/>
                      <p:cNvPicPr preferRelativeResize="0"/>
                      <p:nvPr/>
                    </p:nvPicPr>
                    <p:blipFill rotWithShape="1">
                      <a:blip r:embed="rId15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14637" y="424234"/>
                        <a:ext cx="1573184" cy="17146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33" name="Google Shape;233;p2"/>
                      <p:cNvPicPr preferRelativeResize="0"/>
                      <p:nvPr/>
                    </p:nvPicPr>
                    <p:blipFill rotWithShape="1">
                      <a:blip r:embed="rId16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86405" y="424232"/>
                        <a:ext cx="1573184" cy="17146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34" name="Google Shape;234;p2"/>
                      <p:cNvPicPr preferRelativeResize="0"/>
                      <p:nvPr/>
                    </p:nvPicPr>
                    <p:blipFill rotWithShape="1">
                      <a:blip r:embed="rId17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400521" y="424233"/>
                        <a:ext cx="1573184" cy="17146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35" name="Google Shape;235;p2"/>
                      <p:cNvPicPr preferRelativeResize="0"/>
                      <p:nvPr/>
                    </p:nvPicPr>
                    <p:blipFill rotWithShape="1">
                      <a:blip r:embed="rId18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228753" y="424235"/>
                        <a:ext cx="1573184" cy="17146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236" name="Google Shape;236;p2"/>
                      <p:cNvSpPr/>
                      <p:nvPr/>
                    </p:nvSpPr>
                    <p:spPr>
                      <a:xfrm>
                        <a:off x="131266" y="157397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5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237" name="Google Shape;237;p2"/>
                    <p:cNvSpPr/>
                    <p:nvPr/>
                  </p:nvSpPr>
                  <p:spPr>
                    <a:xfrm>
                      <a:off x="509623" y="453791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238" name="Google Shape;238;p2"/>
                  <p:cNvSpPr/>
                  <p:nvPr/>
                </p:nvSpPr>
                <p:spPr>
                  <a:xfrm>
                    <a:off x="793733" y="2051861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39" name="Google Shape;239;p2"/>
                  <p:cNvSpPr/>
                  <p:nvPr/>
                </p:nvSpPr>
                <p:spPr>
                  <a:xfrm>
                    <a:off x="2400561" y="2047538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40" name="Google Shape;240;p2"/>
                  <p:cNvSpPr/>
                  <p:nvPr/>
                </p:nvSpPr>
                <p:spPr>
                  <a:xfrm>
                    <a:off x="3985673" y="2047538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41" name="Google Shape;241;p2"/>
                  <p:cNvSpPr/>
                  <p:nvPr/>
                </p:nvSpPr>
                <p:spPr>
                  <a:xfrm>
                    <a:off x="5568353" y="2047536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242" name="Google Shape;242;p2"/>
                <p:cNvSpPr/>
                <p:nvPr/>
              </p:nvSpPr>
              <p:spPr>
                <a:xfrm>
                  <a:off x="2108207" y="453791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243" name="Google Shape;243;p2"/>
              <p:cNvSpPr/>
              <p:nvPr/>
            </p:nvSpPr>
            <p:spPr>
              <a:xfrm>
                <a:off x="3513410" y="448319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244" name="Google Shape;244;p2"/>
            <p:cNvSpPr/>
            <p:nvPr/>
          </p:nvSpPr>
          <p:spPr>
            <a:xfrm>
              <a:off x="5170097" y="448318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48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3"/>
          <p:cNvSpPr/>
          <p:nvPr/>
        </p:nvSpPr>
        <p:spPr>
          <a:xfrm>
            <a:off x="143829" y="6413652"/>
            <a:ext cx="6492900" cy="9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just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. Figure </a:t>
            </a:r>
            <a:r>
              <a:rPr b="1" lang="en-US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b="0" i="0" lang="en-US" sz="1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Anthropometric curves showing the P50 (blue), P10/P90 (light green)</a:t>
            </a:r>
            <a:r>
              <a:rPr lang="en-US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</a:t>
            </a:r>
            <a:r>
              <a:rPr b="0" i="0" lang="en-US" sz="1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3/P97 (red)</a:t>
            </a:r>
            <a:r>
              <a:rPr b="0" i="0" lang="en-US" sz="1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ercentiles. Patient measurements are indicated by a dark green </a:t>
            </a:r>
            <a:r>
              <a:rPr lang="en-US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ot</a:t>
            </a:r>
            <a:r>
              <a:rPr b="0" i="0" lang="en-US" sz="1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The mid parental height is shown </a:t>
            </a:r>
            <a:r>
              <a:rPr lang="en-US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sing a </a:t>
            </a:r>
            <a:r>
              <a:rPr b="0" i="0" lang="en-US" sz="1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d diamond (paternal and maternal height in blue and pink diamonds</a:t>
            </a:r>
            <a:r>
              <a:rPr lang="en-US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b="0" i="0" lang="en-US" sz="1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spectively).</a:t>
            </a:r>
            <a:endParaRPr b="0" i="0" sz="14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250" name="Google Shape;250;p3"/>
          <p:cNvGrpSpPr/>
          <p:nvPr/>
        </p:nvGrpSpPr>
        <p:grpSpPr>
          <a:xfrm>
            <a:off x="243139" y="2245147"/>
            <a:ext cx="6402703" cy="1976044"/>
            <a:chOff x="131266" y="2233582"/>
            <a:chExt cx="6402703" cy="1976044"/>
          </a:xfrm>
        </p:grpSpPr>
        <p:grpSp>
          <p:nvGrpSpPr>
            <p:cNvPr id="251" name="Google Shape;251;p3"/>
            <p:cNvGrpSpPr/>
            <p:nvPr/>
          </p:nvGrpSpPr>
          <p:grpSpPr>
            <a:xfrm>
              <a:off x="131266" y="2233582"/>
              <a:ext cx="6402703" cy="1976044"/>
              <a:chOff x="131266" y="2233582"/>
              <a:chExt cx="6402703" cy="1976044"/>
            </a:xfrm>
          </p:grpSpPr>
          <p:grpSp>
            <p:nvGrpSpPr>
              <p:cNvPr id="252" name="Google Shape;252;p3"/>
              <p:cNvGrpSpPr/>
              <p:nvPr/>
            </p:nvGrpSpPr>
            <p:grpSpPr>
              <a:xfrm>
                <a:off x="131266" y="2233582"/>
                <a:ext cx="6402703" cy="1976044"/>
                <a:chOff x="131266" y="2233582"/>
                <a:chExt cx="6402703" cy="1976044"/>
              </a:xfrm>
            </p:grpSpPr>
            <p:grpSp>
              <p:nvGrpSpPr>
                <p:cNvPr id="253" name="Google Shape;253;p3"/>
                <p:cNvGrpSpPr/>
                <p:nvPr/>
              </p:nvGrpSpPr>
              <p:grpSpPr>
                <a:xfrm>
                  <a:off x="131266" y="2233582"/>
                  <a:ext cx="6402703" cy="1976044"/>
                  <a:chOff x="131266" y="2233582"/>
                  <a:chExt cx="6402703" cy="1976044"/>
                </a:xfrm>
              </p:grpSpPr>
              <p:grpSp>
                <p:nvGrpSpPr>
                  <p:cNvPr id="254" name="Google Shape;254;p3"/>
                  <p:cNvGrpSpPr/>
                  <p:nvPr/>
                </p:nvGrpSpPr>
                <p:grpSpPr>
                  <a:xfrm>
                    <a:off x="131266" y="2233582"/>
                    <a:ext cx="6402703" cy="1976044"/>
                    <a:chOff x="131266" y="2233582"/>
                    <a:chExt cx="6402703" cy="1976044"/>
                  </a:xfrm>
                </p:grpSpPr>
                <p:grpSp>
                  <p:nvGrpSpPr>
                    <p:cNvPr id="255" name="Google Shape;255;p3"/>
                    <p:cNvGrpSpPr/>
                    <p:nvPr/>
                  </p:nvGrpSpPr>
                  <p:grpSpPr>
                    <a:xfrm>
                      <a:off x="131266" y="2233582"/>
                      <a:ext cx="6402703" cy="1976044"/>
                      <a:chOff x="131266" y="2453348"/>
                      <a:chExt cx="6402703" cy="1976044"/>
                    </a:xfrm>
                  </p:grpSpPr>
                  <p:pic>
                    <p:nvPicPr>
                      <p:cNvPr id="256" name="Google Shape;256;p3"/>
                      <p:cNvPicPr preferRelativeResize="0"/>
                      <p:nvPr/>
                    </p:nvPicPr>
                    <p:blipFill rotWithShape="1">
                      <a:blip r:embed="rId3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224641" y="2720186"/>
                        <a:ext cx="1568764" cy="170920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57" name="Google Shape;257;p3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07051" y="2727010"/>
                        <a:ext cx="1562501" cy="17023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58" name="Google Shape;258;p3"/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383197" y="2727010"/>
                        <a:ext cx="1562501" cy="17023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59" name="Google Shape;259;p3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71469" y="2727010"/>
                        <a:ext cx="1562500" cy="17023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260" name="Google Shape;260;p3"/>
                      <p:cNvSpPr/>
                      <p:nvPr/>
                    </p:nvSpPr>
                    <p:spPr>
                      <a:xfrm>
                        <a:off x="131266" y="2453348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10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261" name="Google Shape;261;p3"/>
                    <p:cNvSpPr/>
                    <p:nvPr/>
                  </p:nvSpPr>
                  <p:spPr>
                    <a:xfrm>
                      <a:off x="476562" y="2528736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262" name="Google Shape;262;p3"/>
                  <p:cNvSpPr/>
                  <p:nvPr/>
                </p:nvSpPr>
                <p:spPr>
                  <a:xfrm>
                    <a:off x="805407" y="4118311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63" name="Google Shape;263;p3"/>
                  <p:cNvSpPr/>
                  <p:nvPr/>
                </p:nvSpPr>
                <p:spPr>
                  <a:xfrm>
                    <a:off x="2409020" y="411831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64" name="Google Shape;264;p3"/>
                  <p:cNvSpPr/>
                  <p:nvPr/>
                </p:nvSpPr>
                <p:spPr>
                  <a:xfrm>
                    <a:off x="3963402" y="411831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65" name="Google Shape;265;p3"/>
                  <p:cNvSpPr/>
                  <p:nvPr/>
                </p:nvSpPr>
                <p:spPr>
                  <a:xfrm>
                    <a:off x="5529301" y="4118309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266" name="Google Shape;266;p3"/>
                <p:cNvSpPr/>
                <p:nvPr/>
              </p:nvSpPr>
              <p:spPr>
                <a:xfrm>
                  <a:off x="2077646" y="2537404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267" name="Google Shape;267;p3"/>
              <p:cNvSpPr/>
              <p:nvPr/>
            </p:nvSpPr>
            <p:spPr>
              <a:xfrm>
                <a:off x="3491141" y="2528736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268" name="Google Shape;268;p3"/>
            <p:cNvSpPr/>
            <p:nvPr/>
          </p:nvSpPr>
          <p:spPr>
            <a:xfrm>
              <a:off x="5157414" y="2528306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269" name="Google Shape;269;p3"/>
          <p:cNvGrpSpPr/>
          <p:nvPr/>
        </p:nvGrpSpPr>
        <p:grpSpPr>
          <a:xfrm>
            <a:off x="252252" y="157397"/>
            <a:ext cx="6415384" cy="1983037"/>
            <a:chOff x="131266" y="157397"/>
            <a:chExt cx="6415384" cy="1983037"/>
          </a:xfrm>
        </p:grpSpPr>
        <p:grpSp>
          <p:nvGrpSpPr>
            <p:cNvPr id="270" name="Google Shape;270;p3"/>
            <p:cNvGrpSpPr/>
            <p:nvPr/>
          </p:nvGrpSpPr>
          <p:grpSpPr>
            <a:xfrm>
              <a:off x="131266" y="157397"/>
              <a:ext cx="6415384" cy="1983037"/>
              <a:chOff x="131266" y="157397"/>
              <a:chExt cx="6415384" cy="1983037"/>
            </a:xfrm>
          </p:grpSpPr>
          <p:grpSp>
            <p:nvGrpSpPr>
              <p:cNvPr id="271" name="Google Shape;271;p3"/>
              <p:cNvGrpSpPr/>
              <p:nvPr/>
            </p:nvGrpSpPr>
            <p:grpSpPr>
              <a:xfrm>
                <a:off x="131266" y="157397"/>
                <a:ext cx="6415384" cy="1983037"/>
                <a:chOff x="131266" y="157397"/>
                <a:chExt cx="6415384" cy="1983037"/>
              </a:xfrm>
            </p:grpSpPr>
            <p:grpSp>
              <p:nvGrpSpPr>
                <p:cNvPr id="272" name="Google Shape;272;p3"/>
                <p:cNvGrpSpPr/>
                <p:nvPr/>
              </p:nvGrpSpPr>
              <p:grpSpPr>
                <a:xfrm>
                  <a:off x="131266" y="157397"/>
                  <a:ext cx="6415384" cy="1983037"/>
                  <a:chOff x="131266" y="157397"/>
                  <a:chExt cx="6415384" cy="1983037"/>
                </a:xfrm>
              </p:grpSpPr>
              <p:grpSp>
                <p:nvGrpSpPr>
                  <p:cNvPr id="273" name="Google Shape;273;p3"/>
                  <p:cNvGrpSpPr/>
                  <p:nvPr/>
                </p:nvGrpSpPr>
                <p:grpSpPr>
                  <a:xfrm>
                    <a:off x="131266" y="157397"/>
                    <a:ext cx="6415384" cy="1983037"/>
                    <a:chOff x="131266" y="157397"/>
                    <a:chExt cx="6415384" cy="1983037"/>
                  </a:xfrm>
                </p:grpSpPr>
                <p:grpSp>
                  <p:nvGrpSpPr>
                    <p:cNvPr id="274" name="Google Shape;274;p3"/>
                    <p:cNvGrpSpPr/>
                    <p:nvPr/>
                  </p:nvGrpSpPr>
                  <p:grpSpPr>
                    <a:xfrm>
                      <a:off x="131266" y="157397"/>
                      <a:ext cx="6415384" cy="1983037"/>
                      <a:chOff x="131266" y="157397"/>
                      <a:chExt cx="6415384" cy="1983037"/>
                    </a:xfrm>
                  </p:grpSpPr>
                  <p:pic>
                    <p:nvPicPr>
                      <p:cNvPr id="275" name="Google Shape;275;p3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07052" y="431225"/>
                        <a:ext cx="1568765" cy="170920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76" name="Google Shape;276;p3"/>
                      <p:cNvPicPr preferRelativeResize="0"/>
                      <p:nvPr/>
                    </p:nvPicPr>
                    <p:blipFill rotWithShape="1">
                      <a:blip r:embed="rId8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389463" y="424235"/>
                        <a:ext cx="1575183" cy="171619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77" name="Google Shape;277;p3"/>
                      <p:cNvPicPr preferRelativeResize="0"/>
                      <p:nvPr/>
                    </p:nvPicPr>
                    <p:blipFill rotWithShape="1">
                      <a:blip r:embed="rId9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4971469" y="424234"/>
                        <a:ext cx="1575181" cy="171619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78" name="Google Shape;278;p3"/>
                      <p:cNvPicPr preferRelativeResize="0"/>
                      <p:nvPr/>
                    </p:nvPicPr>
                    <p:blipFill rotWithShape="1">
                      <a:blip r:embed="rId10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224640" y="431226"/>
                        <a:ext cx="1568766" cy="170920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279" name="Google Shape;279;p3"/>
                      <p:cNvSpPr/>
                      <p:nvPr/>
                    </p:nvSpPr>
                    <p:spPr>
                      <a:xfrm>
                        <a:off x="131266" y="157397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9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280" name="Google Shape;280;p3"/>
                    <p:cNvSpPr/>
                    <p:nvPr/>
                  </p:nvSpPr>
                  <p:spPr>
                    <a:xfrm>
                      <a:off x="471167" y="460920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281" name="Google Shape;281;p3"/>
                  <p:cNvSpPr/>
                  <p:nvPr/>
                </p:nvSpPr>
                <p:spPr>
                  <a:xfrm>
                    <a:off x="771311" y="2049607"/>
                    <a:ext cx="485400" cy="70200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82" name="Google Shape;282;p3"/>
                  <p:cNvSpPr/>
                  <p:nvPr/>
                </p:nvSpPr>
                <p:spPr>
                  <a:xfrm>
                    <a:off x="2367344" y="204961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83" name="Google Shape;283;p3"/>
                  <p:cNvSpPr/>
                  <p:nvPr/>
                </p:nvSpPr>
                <p:spPr>
                  <a:xfrm>
                    <a:off x="3963402" y="2049610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84" name="Google Shape;284;p3"/>
                  <p:cNvSpPr/>
                  <p:nvPr/>
                </p:nvSpPr>
                <p:spPr>
                  <a:xfrm>
                    <a:off x="5529301" y="2052543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285" name="Google Shape;285;p3"/>
                <p:cNvSpPr/>
                <p:nvPr/>
              </p:nvSpPr>
              <p:spPr>
                <a:xfrm>
                  <a:off x="2055842" y="465469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286" name="Google Shape;286;p3"/>
              <p:cNvSpPr/>
              <p:nvPr/>
            </p:nvSpPr>
            <p:spPr>
              <a:xfrm>
                <a:off x="3473065" y="451822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287" name="Google Shape;287;p3"/>
            <p:cNvSpPr/>
            <p:nvPr/>
          </p:nvSpPr>
          <p:spPr>
            <a:xfrm>
              <a:off x="5131045" y="451433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288" name="Google Shape;288;p3"/>
          <p:cNvGrpSpPr/>
          <p:nvPr/>
        </p:nvGrpSpPr>
        <p:grpSpPr>
          <a:xfrm>
            <a:off x="274046" y="4325905"/>
            <a:ext cx="6440125" cy="1983034"/>
            <a:chOff x="131635" y="4302774"/>
            <a:chExt cx="6440125" cy="1983034"/>
          </a:xfrm>
        </p:grpSpPr>
        <p:grpSp>
          <p:nvGrpSpPr>
            <p:cNvPr id="289" name="Google Shape;289;p3"/>
            <p:cNvGrpSpPr/>
            <p:nvPr/>
          </p:nvGrpSpPr>
          <p:grpSpPr>
            <a:xfrm>
              <a:off x="131635" y="4302774"/>
              <a:ext cx="6440125" cy="1983034"/>
              <a:chOff x="131635" y="4302774"/>
              <a:chExt cx="6440125" cy="1983034"/>
            </a:xfrm>
          </p:grpSpPr>
          <p:grpSp>
            <p:nvGrpSpPr>
              <p:cNvPr id="290" name="Google Shape;290;p3"/>
              <p:cNvGrpSpPr/>
              <p:nvPr/>
            </p:nvGrpSpPr>
            <p:grpSpPr>
              <a:xfrm>
                <a:off x="131635" y="4302774"/>
                <a:ext cx="6440125" cy="1983034"/>
                <a:chOff x="131635" y="4302774"/>
                <a:chExt cx="6440125" cy="1983034"/>
              </a:xfrm>
            </p:grpSpPr>
            <p:grpSp>
              <p:nvGrpSpPr>
                <p:cNvPr id="291" name="Google Shape;291;p3"/>
                <p:cNvGrpSpPr/>
                <p:nvPr/>
              </p:nvGrpSpPr>
              <p:grpSpPr>
                <a:xfrm>
                  <a:off x="131635" y="4302774"/>
                  <a:ext cx="6440125" cy="1983034"/>
                  <a:chOff x="131635" y="4302774"/>
                  <a:chExt cx="6440125" cy="1983034"/>
                </a:xfrm>
              </p:grpSpPr>
              <p:grpSp>
                <p:nvGrpSpPr>
                  <p:cNvPr id="292" name="Google Shape;292;p3"/>
                  <p:cNvGrpSpPr/>
                  <p:nvPr/>
                </p:nvGrpSpPr>
                <p:grpSpPr>
                  <a:xfrm>
                    <a:off x="131635" y="4302774"/>
                    <a:ext cx="6440125" cy="1983034"/>
                    <a:chOff x="131635" y="4302774"/>
                    <a:chExt cx="6440125" cy="1983034"/>
                  </a:xfrm>
                </p:grpSpPr>
                <p:grpSp>
                  <p:nvGrpSpPr>
                    <p:cNvPr id="293" name="Google Shape;293;p3"/>
                    <p:cNvGrpSpPr/>
                    <p:nvPr/>
                  </p:nvGrpSpPr>
                  <p:grpSpPr>
                    <a:xfrm>
                      <a:off x="131635" y="4302774"/>
                      <a:ext cx="6440125" cy="1983034"/>
                      <a:chOff x="131635" y="4302774"/>
                      <a:chExt cx="6440125" cy="1983034"/>
                    </a:xfrm>
                  </p:grpSpPr>
                  <p:pic>
                    <p:nvPicPr>
                      <p:cNvPr id="294" name="Google Shape;294;p3"/>
                      <p:cNvPicPr preferRelativeResize="0"/>
                      <p:nvPr/>
                    </p:nvPicPr>
                    <p:blipFill rotWithShape="1">
                      <a:blip r:embed="rId11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224639" y="4576601"/>
                        <a:ext cx="1568765" cy="170920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95" name="Google Shape;295;p3"/>
                      <p:cNvPicPr preferRelativeResize="0"/>
                      <p:nvPr/>
                    </p:nvPicPr>
                    <p:blipFill rotWithShape="1">
                      <a:blip r:embed="rId12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1807050" y="4579472"/>
                        <a:ext cx="1566129" cy="170633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96" name="Google Shape;296;p3"/>
                      <p:cNvPicPr preferRelativeResize="0"/>
                      <p:nvPr/>
                    </p:nvPicPr>
                    <p:blipFill rotWithShape="1">
                      <a:blip r:embed="rId13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3403704" y="4576601"/>
                        <a:ext cx="1568767" cy="170920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pic>
                    <p:nvPicPr>
                      <p:cNvPr id="297" name="Google Shape;297;p3"/>
                      <p:cNvPicPr preferRelativeResize="0"/>
                      <p:nvPr/>
                    </p:nvPicPr>
                    <p:blipFill rotWithShape="1">
                      <a:blip r:embed="rId14">
                        <a:alphaModFix/>
                      </a:blip>
                      <a:srcRect b="0" l="0" r="0" t="0"/>
                      <a:stretch/>
                    </p:blipFill>
                    <p:spPr>
                      <a:xfrm>
                        <a:off x="5002996" y="4576601"/>
                        <a:ext cx="1568764" cy="170920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  <p:sp>
                    <p:nvSpPr>
                      <p:cNvPr id="298" name="Google Shape;298;p3"/>
                      <p:cNvSpPr/>
                      <p:nvPr/>
                    </p:nvSpPr>
                    <p:spPr>
                      <a:xfrm>
                        <a:off x="131635" y="4302774"/>
                        <a:ext cx="773775" cy="266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anchorCtr="0" anchor="t" bIns="34275" lIns="68550" spcFirstLastPara="1" rIns="68550" wrap="square" tIns="34275">
                        <a:spAutoFit/>
                      </a:bodyPr>
                      <a:lstStyle/>
                      <a:p>
                        <a:pPr indent="0" lvl="0" marL="0" marR="0" rtl="0" algn="ctr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b="0" i="0" lang="en-US" sz="1200" u="none" cap="none" strike="noStrik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tient 11</a:t>
                        </a:r>
                        <a:endParaRPr b="0" i="0" sz="12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  <p:sp>
                  <p:nvSpPr>
                    <p:cNvPr id="299" name="Google Shape;299;p3"/>
                    <p:cNvSpPr/>
                    <p:nvPr/>
                  </p:nvSpPr>
                  <p:spPr>
                    <a:xfrm>
                      <a:off x="493877" y="4601974"/>
                      <a:ext cx="1064917" cy="10080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 cap="flat" cmpd="sng" w="12700">
                      <a:solidFill>
                        <a:schemeClr val="lt1"/>
                      </a:solidFill>
                      <a:prstDash val="solid"/>
                      <a:miter lim="800000"/>
                      <a:headEnd len="sm" w="sm" type="none"/>
                      <a:tailEnd len="sm" w="sm" type="none"/>
                    </a:ln>
                  </p:spPr>
                  <p:txBody>
                    <a:bodyPr anchorCtr="0" anchor="ctr" bIns="45700" lIns="91425" spcFirstLastPara="1" rIns="91425" wrap="square" tIns="45700">
                      <a:noAutofit/>
                    </a:bodyPr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ight in children from 0 to 22 years (cm)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400" u="none" cap="none" strike="noStrik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anish transversal study 2010</a:t>
                      </a:r>
                      <a:endParaRPr b="1" i="0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300" name="Google Shape;300;p3"/>
                  <p:cNvSpPr/>
                  <p:nvPr/>
                </p:nvSpPr>
                <p:spPr>
                  <a:xfrm>
                    <a:off x="805407" y="6197446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301" name="Google Shape;301;p3"/>
                  <p:cNvSpPr/>
                  <p:nvPr/>
                </p:nvSpPr>
                <p:spPr>
                  <a:xfrm>
                    <a:off x="2382211" y="6197445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302" name="Google Shape;302;p3"/>
                  <p:cNvSpPr/>
                  <p:nvPr/>
                </p:nvSpPr>
                <p:spPr>
                  <a:xfrm>
                    <a:off x="3992511" y="6197444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303" name="Google Shape;303;p3"/>
                  <p:cNvSpPr/>
                  <p:nvPr/>
                </p:nvSpPr>
                <p:spPr>
                  <a:xfrm>
                    <a:off x="5555670" y="6197443"/>
                    <a:ext cx="485522" cy="70165"/>
                  </a:xfrm>
                  <a:prstGeom prst="rect">
                    <a:avLst/>
                  </a:prstGeom>
                  <a:solidFill>
                    <a:schemeClr val="lt1"/>
                  </a:solidFill>
                  <a:ln cap="flat" cmpd="sng" w="12700">
                    <a:solidFill>
                      <a:schemeClr val="lt1"/>
                    </a:solidFill>
                    <a:prstDash val="solid"/>
                    <a:miter lim="800000"/>
                    <a:headEnd len="sm" w="sm" type="none"/>
                    <a:tailEnd len="sm" w="sm" type="none"/>
                  </a:ln>
                </p:spPr>
                <p:txBody>
                  <a:bodyPr anchorCtr="0" anchor="ctr" bIns="45700" lIns="91425" spcFirstLastPara="1" rIns="91425" wrap="square" tIns="45700">
                    <a:noAutofit/>
                  </a:bodyPr>
                  <a:lstStyle/>
                  <a:p>
                    <a:pPr indent="0" lvl="0" marL="0" marR="0" rtl="0" algn="ctr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b="1" i="0" lang="en-US" sz="400" u="none" cap="none" strike="noStrike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rPr>
                      <a:t>Age (years)</a:t>
                    </a:r>
                    <a:endParaRPr b="1" i="0" sz="11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sp>
              <p:nvSpPr>
                <p:cNvPr id="304" name="Google Shape;304;p3"/>
                <p:cNvSpPr/>
                <p:nvPr/>
              </p:nvSpPr>
              <p:spPr>
                <a:xfrm>
                  <a:off x="2004697" y="4601759"/>
                  <a:ext cx="1064917" cy="100800"/>
                </a:xfrm>
                <a:prstGeom prst="rect">
                  <a:avLst/>
                </a:prstGeom>
                <a:solidFill>
                  <a:schemeClr val="lt1"/>
                </a:solidFill>
                <a:ln cap="flat" cmpd="sng" w="12700">
                  <a:solidFill>
                    <a:schemeClr val="lt1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Weight in children from 0 to 22 years (kg)</a:t>
                  </a:r>
                  <a:endParaRPr/>
                </a:p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b="1" i="0" lang="en-US" sz="400" u="none" cap="none" strike="noStrik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Spanish transversal study 2010</a:t>
                  </a:r>
                  <a:endParaRPr b="1" i="0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sp>
            <p:nvSpPr>
              <p:cNvPr id="305" name="Google Shape;305;p3"/>
              <p:cNvSpPr/>
              <p:nvPr/>
            </p:nvSpPr>
            <p:spPr>
              <a:xfrm>
                <a:off x="3476719" y="4601974"/>
                <a:ext cx="1430043" cy="100800"/>
              </a:xfrm>
              <a:prstGeom prst="rect">
                <a:avLst/>
              </a:prstGeom>
              <a:solidFill>
                <a:schemeClr val="lt1"/>
              </a:solidFill>
              <a:ln cap="flat" cmpd="sng" w="12700">
                <a:solidFill>
                  <a:schemeClr val="lt1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ody mass index in children from 0 to 22 years (kg/m2)</a:t>
                </a:r>
                <a:endParaRPr/>
              </a:p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1" i="0" lang="en-US" sz="4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panish transversal study 2010</a:t>
                </a:r>
                <a:endParaRPr b="1" i="0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306" name="Google Shape;306;p3"/>
            <p:cNvSpPr/>
            <p:nvPr/>
          </p:nvSpPr>
          <p:spPr>
            <a:xfrm>
              <a:off x="5111702" y="4601974"/>
              <a:ext cx="1282034" cy="100800"/>
            </a:xfrm>
            <a:prstGeom prst="rect">
              <a:avLst/>
            </a:prstGeom>
            <a:solidFill>
              <a:schemeClr val="lt1"/>
            </a:solidFill>
            <a:ln cap="flat" cmpd="sng" w="12700">
              <a:solidFill>
                <a:schemeClr val="lt1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ephalic circumference in children (cm)</a:t>
              </a:r>
              <a:endParaRPr/>
            </a:p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i="0" lang="en-US" sz="4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panish transversal study 2010</a:t>
              </a:r>
              <a:endParaRPr b="1" i="0" sz="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Tema de Office">
  <a:themeElements>
    <a:clrScheme name="Tema d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10-30T08:19:59Z</dcterms:created>
  <dc:creator>Soengas Gonda.Emma María</dc:creator>
</cp:coreProperties>
</file>